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2140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3743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4796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6864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8830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132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4549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9308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3571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9690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49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0A5C1-0E5D-4522-8C37-678AC59A05D2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66911-661C-487C-93BB-ADB8154289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8516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图片 42" descr="FAH分析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7610" y="1092277"/>
            <a:ext cx="8691629" cy="27959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文本框 3"/>
          <p:cNvSpPr txBox="1"/>
          <p:nvPr/>
        </p:nvSpPr>
        <p:spPr>
          <a:xfrm>
            <a:off x="1787610" y="3888259"/>
            <a:ext cx="910913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otein sequence alignment of FAH superfamily. Red boxes indicate His-rich motifs. The abbreviations of diverse species: At,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assica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s,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cumis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tiv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m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y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yz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tiv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d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chypodium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achy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6920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P R 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Windows User</cp:lastModifiedBy>
  <cp:revision>1</cp:revision>
  <dcterms:created xsi:type="dcterms:W3CDTF">2019-02-22T04:13:06Z</dcterms:created>
  <dcterms:modified xsi:type="dcterms:W3CDTF">2019-02-22T04:13:11Z</dcterms:modified>
</cp:coreProperties>
</file>